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2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en\Documents\Hyperglycemia%20manuscript\HG%20bar%20charts%20Table%2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en\Documents\Hyperglycemia%20manuscript\HG%20bar%20charts%20Table%20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en\Documents\Hyperglycemia%20manuscript\HG%20bar%20charts%20Table%20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en\Documents\Hyperglycemia%20manuscript\HG%20bar%20charts%20Table%20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len\Documents\Hyperglycemia%20manuscript\Resubmission\Revised%20SHG%20analysis%20010318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Studies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Site of sampling'!$A$2:$A$6</c:f>
              <c:strCache>
                <c:ptCount val="5"/>
                <c:pt idx="0">
                  <c:v>NR</c:v>
                </c:pt>
                <c:pt idx="1">
                  <c:v>Capillary</c:v>
                </c:pt>
                <c:pt idx="2">
                  <c:v>Arterial</c:v>
                </c:pt>
                <c:pt idx="3">
                  <c:v>Venous</c:v>
                </c:pt>
                <c:pt idx="4">
                  <c:v>Multiple</c:v>
                </c:pt>
              </c:strCache>
            </c:strRef>
          </c:cat>
          <c:val>
            <c:numRef>
              <c:f>'Site of sampling'!$B$2:$B$6</c:f>
              <c:numCache>
                <c:formatCode>General</c:formatCode>
                <c:ptCount val="5"/>
                <c:pt idx="0">
                  <c:v>30</c:v>
                </c:pt>
                <c:pt idx="1">
                  <c:v>3</c:v>
                </c:pt>
                <c:pt idx="2">
                  <c:v>3</c:v>
                </c:pt>
                <c:pt idx="3">
                  <c:v>0</c:v>
                </c:pt>
                <c:pt idx="4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D8-427B-A891-949B92A25B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66853688"/>
        <c:axId val="451938640"/>
      </c:barChart>
      <c:lineChart>
        <c:grouping val="standard"/>
        <c:varyColors val="0"/>
        <c:ser>
          <c:idx val="1"/>
          <c:order val="1"/>
          <c:tx>
            <c:v>Patients</c:v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'Site of sampling'!$C$2:$C$6</c:f>
              <c:numCache>
                <c:formatCode>General</c:formatCode>
                <c:ptCount val="5"/>
                <c:pt idx="0">
                  <c:v>213526</c:v>
                </c:pt>
                <c:pt idx="1">
                  <c:v>1490</c:v>
                </c:pt>
                <c:pt idx="2">
                  <c:v>6394</c:v>
                </c:pt>
                <c:pt idx="3">
                  <c:v>0</c:v>
                </c:pt>
                <c:pt idx="4">
                  <c:v>3150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4D8-427B-A891-949B92A25B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1941776"/>
        <c:axId val="451941384"/>
      </c:lineChart>
      <c:catAx>
        <c:axId val="6668536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Site of sampling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1938640"/>
        <c:crosses val="autoZero"/>
        <c:auto val="1"/>
        <c:lblAlgn val="ctr"/>
        <c:lblOffset val="100"/>
        <c:noMultiLvlLbl val="0"/>
      </c:catAx>
      <c:valAx>
        <c:axId val="451938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stud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6853688"/>
        <c:crosses val="autoZero"/>
        <c:crossBetween val="between"/>
      </c:valAx>
      <c:valAx>
        <c:axId val="451941384"/>
        <c:scaling>
          <c:orientation val="minMax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</a:t>
                </a:r>
                <a:r>
                  <a:rPr lang="en-GB" baseline="0"/>
                  <a:t> patients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1941776"/>
        <c:crosses val="max"/>
        <c:crossBetween val="between"/>
      </c:valAx>
      <c:catAx>
        <c:axId val="451941776"/>
        <c:scaling>
          <c:orientation val="minMax"/>
        </c:scaling>
        <c:delete val="1"/>
        <c:axPos val="b"/>
        <c:majorTickMark val="none"/>
        <c:minorTickMark val="none"/>
        <c:tickLblPos val="nextTo"/>
        <c:crossAx val="45194138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Studies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Meter!$A$2:$A$6</c:f>
              <c:strCache>
                <c:ptCount val="5"/>
                <c:pt idx="0">
                  <c:v>NR</c:v>
                </c:pt>
                <c:pt idx="1">
                  <c:v>POC/gluc</c:v>
                </c:pt>
                <c:pt idx="2">
                  <c:v>BGA</c:v>
                </c:pt>
                <c:pt idx="3">
                  <c:v>Lab</c:v>
                </c:pt>
                <c:pt idx="4">
                  <c:v>Multiple</c:v>
                </c:pt>
              </c:strCache>
            </c:strRef>
          </c:cat>
          <c:val>
            <c:numRef>
              <c:f>Meter!$B$2:$B$6</c:f>
              <c:numCache>
                <c:formatCode>General</c:formatCode>
                <c:ptCount val="5"/>
                <c:pt idx="0">
                  <c:v>20</c:v>
                </c:pt>
                <c:pt idx="1">
                  <c:v>8</c:v>
                </c:pt>
                <c:pt idx="2">
                  <c:v>2</c:v>
                </c:pt>
                <c:pt idx="3">
                  <c:v>3</c:v>
                </c:pt>
                <c:pt idx="4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9B-4980-B210-2843CC8EF0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1940992"/>
        <c:axId val="451940208"/>
      </c:barChart>
      <c:lineChart>
        <c:grouping val="standard"/>
        <c:varyColors val="0"/>
        <c:ser>
          <c:idx val="1"/>
          <c:order val="1"/>
          <c:tx>
            <c:v>Patients</c:v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Meter!$C$2:$C$6</c:f>
              <c:numCache>
                <c:formatCode>#,##0</c:formatCode>
                <c:ptCount val="5"/>
                <c:pt idx="0">
                  <c:v>14779</c:v>
                </c:pt>
                <c:pt idx="1">
                  <c:v>10529</c:v>
                </c:pt>
                <c:pt idx="2" formatCode="General">
                  <c:v>566</c:v>
                </c:pt>
                <c:pt idx="3">
                  <c:v>260044</c:v>
                </c:pt>
                <c:pt idx="4">
                  <c:v>2505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9B-4980-B210-2843CC8EF0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1940600"/>
        <c:axId val="451942168"/>
      </c:lineChart>
      <c:catAx>
        <c:axId val="4519409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Meter use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1940208"/>
        <c:crosses val="autoZero"/>
        <c:auto val="1"/>
        <c:lblAlgn val="ctr"/>
        <c:lblOffset val="100"/>
        <c:noMultiLvlLbl val="0"/>
      </c:catAx>
      <c:valAx>
        <c:axId val="4519402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stud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1940992"/>
        <c:crosses val="autoZero"/>
        <c:crossBetween val="between"/>
      </c:valAx>
      <c:valAx>
        <c:axId val="451942168"/>
        <c:scaling>
          <c:orientation val="minMax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1940600"/>
        <c:crosses val="max"/>
        <c:crossBetween val="between"/>
      </c:valAx>
      <c:catAx>
        <c:axId val="451940600"/>
        <c:scaling>
          <c:orientation val="minMax"/>
        </c:scaling>
        <c:delete val="1"/>
        <c:axPos val="b"/>
        <c:majorTickMark val="none"/>
        <c:minorTickMark val="none"/>
        <c:tickLblPos val="nextTo"/>
        <c:crossAx val="45194216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60867568066172"/>
          <c:y val="5.1425899953249185E-2"/>
          <c:w val="0.79432807627151636"/>
          <c:h val="0.689629048823314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Timing of sampling'!$A$2:$A$12</c:f>
              <c:strCache>
                <c:ptCount val="11"/>
                <c:pt idx="0">
                  <c:v>NR</c:v>
                </c:pt>
                <c:pt idx="1">
                  <c:v>Admission only</c:v>
                </c:pt>
                <c:pt idx="2">
                  <c:v>Hourly</c:v>
                </c:pt>
                <c:pt idx="3">
                  <c:v>Every 2 h</c:v>
                </c:pt>
                <c:pt idx="4">
                  <c:v>Every 3 h</c:v>
                </c:pt>
                <c:pt idx="5">
                  <c:v>Every 4 h</c:v>
                </c:pt>
                <c:pt idx="6">
                  <c:v>4× daily</c:v>
                </c:pt>
                <c:pt idx="7">
                  <c:v>Daily</c:v>
                </c:pt>
                <c:pt idx="8">
                  <c:v>First 24 h</c:v>
                </c:pt>
                <c:pt idx="9">
                  <c:v>First 48 h</c:v>
                </c:pt>
                <c:pt idx="10">
                  <c:v>First 72 h</c:v>
                </c:pt>
              </c:strCache>
            </c:strRef>
          </c:cat>
          <c:val>
            <c:numRef>
              <c:f>'Timing of sampling'!$B$2:$B$12</c:f>
              <c:numCache>
                <c:formatCode>General</c:formatCode>
                <c:ptCount val="11"/>
                <c:pt idx="0">
                  <c:v>16</c:v>
                </c:pt>
                <c:pt idx="1">
                  <c:v>4</c:v>
                </c:pt>
                <c:pt idx="2">
                  <c:v>5</c:v>
                </c:pt>
                <c:pt idx="3">
                  <c:v>1</c:v>
                </c:pt>
                <c:pt idx="4">
                  <c:v>2</c:v>
                </c:pt>
                <c:pt idx="5">
                  <c:v>1</c:v>
                </c:pt>
                <c:pt idx="6">
                  <c:v>1</c:v>
                </c:pt>
                <c:pt idx="7">
                  <c:v>5</c:v>
                </c:pt>
                <c:pt idx="8">
                  <c:v>5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26-4937-A0F8-B6A0FB5DEA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7046784"/>
        <c:axId val="507047960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'Timing of sampling'!$C$2:$C$12</c:f>
              <c:numCache>
                <c:formatCode>General</c:formatCode>
                <c:ptCount val="11"/>
                <c:pt idx="0">
                  <c:v>313070</c:v>
                </c:pt>
                <c:pt idx="1">
                  <c:v>4733</c:v>
                </c:pt>
                <c:pt idx="2">
                  <c:v>6622</c:v>
                </c:pt>
                <c:pt idx="3">
                  <c:v>2782</c:v>
                </c:pt>
                <c:pt idx="4">
                  <c:v>3402</c:v>
                </c:pt>
                <c:pt idx="5">
                  <c:v>228</c:v>
                </c:pt>
                <c:pt idx="6">
                  <c:v>386</c:v>
                </c:pt>
                <c:pt idx="7">
                  <c:v>8480</c:v>
                </c:pt>
                <c:pt idx="8">
                  <c:v>195478</c:v>
                </c:pt>
                <c:pt idx="9">
                  <c:v>516</c:v>
                </c:pt>
                <c:pt idx="10">
                  <c:v>7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726-4937-A0F8-B6A0FB5DEA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7048352"/>
        <c:axId val="507047176"/>
      </c:lineChart>
      <c:catAx>
        <c:axId val="507046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iming of BG sampling</a:t>
                </a:r>
              </a:p>
            </c:rich>
          </c:tx>
          <c:layout>
            <c:manualLayout>
              <c:xMode val="edge"/>
              <c:yMode val="edge"/>
              <c:x val="0.36777217847769028"/>
              <c:y val="0.831510300462717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047960"/>
        <c:crosses val="autoZero"/>
        <c:auto val="1"/>
        <c:lblAlgn val="ctr"/>
        <c:lblOffset val="100"/>
        <c:noMultiLvlLbl val="0"/>
      </c:catAx>
      <c:valAx>
        <c:axId val="507047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stud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046784"/>
        <c:crosses val="autoZero"/>
        <c:crossBetween val="between"/>
      </c:valAx>
      <c:valAx>
        <c:axId val="507047176"/>
        <c:scaling>
          <c:orientation val="minMax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</a:t>
                </a:r>
                <a:r>
                  <a:rPr lang="en-GB" baseline="0"/>
                  <a:t> patients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048352"/>
        <c:crosses val="max"/>
        <c:crossBetween val="between"/>
      </c:valAx>
      <c:catAx>
        <c:axId val="507048352"/>
        <c:scaling>
          <c:orientation val="minMax"/>
        </c:scaling>
        <c:delete val="1"/>
        <c:axPos val="b"/>
        <c:majorTickMark val="none"/>
        <c:minorTickMark val="none"/>
        <c:tickLblPos val="nextTo"/>
        <c:crossAx val="5070471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317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Studies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Target BG range'!$A$2:$A$15</c:f>
              <c:strCache>
                <c:ptCount val="14"/>
                <c:pt idx="0">
                  <c:v>NR</c:v>
                </c:pt>
                <c:pt idx="1">
                  <c:v>60–140</c:v>
                </c:pt>
                <c:pt idx="2">
                  <c:v>70-149</c:v>
                </c:pt>
                <c:pt idx="3">
                  <c:v>72-126</c:v>
                </c:pt>
                <c:pt idx="4">
                  <c:v>72–149</c:v>
                </c:pt>
                <c:pt idx="5">
                  <c:v>74–99</c:v>
                </c:pt>
                <c:pt idx="6">
                  <c:v>80–110</c:v>
                </c:pt>
                <c:pt idx="7">
                  <c:v>80–140</c:v>
                </c:pt>
                <c:pt idx="8">
                  <c:v>90–120</c:v>
                </c:pt>
                <c:pt idx="9">
                  <c:v>90–144</c:v>
                </c:pt>
                <c:pt idx="10">
                  <c:v>&lt;126</c:v>
                </c:pt>
                <c:pt idx="11">
                  <c:v>&lt;140 </c:v>
                </c:pt>
                <c:pt idx="12">
                  <c:v>&lt;150</c:v>
                </c:pt>
                <c:pt idx="13">
                  <c:v>150–200</c:v>
                </c:pt>
              </c:strCache>
            </c:strRef>
          </c:cat>
          <c:val>
            <c:numRef>
              <c:f>'Target BG range'!$B$2:$B$15</c:f>
              <c:numCache>
                <c:formatCode>General</c:formatCode>
                <c:ptCount val="14"/>
                <c:pt idx="0">
                  <c:v>26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4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20-4FE0-A0AF-6250706FF7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7050312"/>
        <c:axId val="507049136"/>
      </c:barChart>
      <c:lineChart>
        <c:grouping val="standard"/>
        <c:varyColors val="0"/>
        <c:ser>
          <c:idx val="1"/>
          <c:order val="1"/>
          <c:tx>
            <c:v>Patients</c:v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'Target BG range'!$C$2:$C$15</c:f>
              <c:numCache>
                <c:formatCode>General</c:formatCode>
                <c:ptCount val="14"/>
                <c:pt idx="0">
                  <c:v>516588</c:v>
                </c:pt>
                <c:pt idx="1">
                  <c:v>338</c:v>
                </c:pt>
                <c:pt idx="2">
                  <c:v>66</c:v>
                </c:pt>
                <c:pt idx="3">
                  <c:v>5828</c:v>
                </c:pt>
                <c:pt idx="4">
                  <c:v>2782</c:v>
                </c:pt>
                <c:pt idx="5">
                  <c:v>279</c:v>
                </c:pt>
                <c:pt idx="6">
                  <c:v>6267</c:v>
                </c:pt>
                <c:pt idx="7">
                  <c:v>395</c:v>
                </c:pt>
                <c:pt idx="8">
                  <c:v>3297</c:v>
                </c:pt>
                <c:pt idx="9">
                  <c:v>228</c:v>
                </c:pt>
                <c:pt idx="10">
                  <c:v>105</c:v>
                </c:pt>
                <c:pt idx="11">
                  <c:v>103</c:v>
                </c:pt>
                <c:pt idx="12">
                  <c:v>170</c:v>
                </c:pt>
                <c:pt idx="13">
                  <c:v>3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B20-4FE0-A0AF-6250706FF7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7049920"/>
        <c:axId val="507049528"/>
      </c:lineChart>
      <c:catAx>
        <c:axId val="5070503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Target BG range (mg/d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049136"/>
        <c:crosses val="autoZero"/>
        <c:auto val="1"/>
        <c:lblAlgn val="ctr"/>
        <c:lblOffset val="100"/>
        <c:noMultiLvlLbl val="0"/>
      </c:catAx>
      <c:valAx>
        <c:axId val="5070491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stud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050312"/>
        <c:crosses val="autoZero"/>
        <c:crossBetween val="between"/>
      </c:valAx>
      <c:valAx>
        <c:axId val="507049528"/>
        <c:scaling>
          <c:orientation val="minMax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</a:t>
                </a:r>
                <a:r>
                  <a:rPr lang="en-GB" baseline="0"/>
                  <a:t> patients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049920"/>
        <c:crosses val="max"/>
        <c:crossBetween val="between"/>
      </c:valAx>
      <c:catAx>
        <c:axId val="507049920"/>
        <c:scaling>
          <c:orientation val="minMax"/>
        </c:scaling>
        <c:delete val="1"/>
        <c:axPos val="b"/>
        <c:majorTickMark val="none"/>
        <c:minorTickMark val="none"/>
        <c:tickLblPos val="nextTo"/>
        <c:crossAx val="50704952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Studies</c:v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Graph!$A$1:$A$16</c:f>
              <c:strCache>
                <c:ptCount val="16"/>
                <c:pt idx="0">
                  <c:v>NR</c:v>
                </c:pt>
                <c:pt idx="1">
                  <c:v>&gt;100</c:v>
                </c:pt>
                <c:pt idx="2">
                  <c:v>&gt;110</c:v>
                </c:pt>
                <c:pt idx="3">
                  <c:v>&gt;126</c:v>
                </c:pt>
                <c:pt idx="4">
                  <c:v>&gt;130</c:v>
                </c:pt>
                <c:pt idx="5">
                  <c:v>&gt;140</c:v>
                </c:pt>
                <c:pt idx="6">
                  <c:v>140-219</c:v>
                </c:pt>
                <c:pt idx="7">
                  <c:v>&gt;141</c:v>
                </c:pt>
                <c:pt idx="8">
                  <c:v>&gt;150</c:v>
                </c:pt>
                <c:pt idx="9">
                  <c:v>150-170</c:v>
                </c:pt>
                <c:pt idx="10">
                  <c:v>&gt;153</c:v>
                </c:pt>
                <c:pt idx="11">
                  <c:v>&gt;160</c:v>
                </c:pt>
                <c:pt idx="12">
                  <c:v>&gt;169</c:v>
                </c:pt>
                <c:pt idx="13">
                  <c:v>&gt;180</c:v>
                </c:pt>
                <c:pt idx="14">
                  <c:v>&gt;200</c:v>
                </c:pt>
                <c:pt idx="15">
                  <c:v>&gt;220</c:v>
                </c:pt>
              </c:strCache>
            </c:strRef>
          </c:cat>
          <c:val>
            <c:numRef>
              <c:f>Graph!$B$1:$B$16</c:f>
              <c:numCache>
                <c:formatCode>General</c:formatCode>
                <c:ptCount val="16"/>
                <c:pt idx="0">
                  <c:v>3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1</c:v>
                </c:pt>
                <c:pt idx="5">
                  <c:v>1</c:v>
                </c:pt>
                <c:pt idx="6">
                  <c:v>2</c:v>
                </c:pt>
                <c:pt idx="7">
                  <c:v>2</c:v>
                </c:pt>
                <c:pt idx="8">
                  <c:v>9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7</c:v>
                </c:pt>
                <c:pt idx="14">
                  <c:v>11</c:v>
                </c:pt>
                <c:pt idx="1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83-438A-8B19-6680FA20F4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9054768"/>
        <c:axId val="669049280"/>
      </c:barChart>
      <c:lineChart>
        <c:grouping val="standard"/>
        <c:varyColors val="0"/>
        <c:ser>
          <c:idx val="1"/>
          <c:order val="1"/>
          <c:tx>
            <c:v>Patients</c:v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cat>
            <c:strRef>
              <c:f>Graph!$A$1:$A$16</c:f>
              <c:strCache>
                <c:ptCount val="16"/>
                <c:pt idx="0">
                  <c:v>NR</c:v>
                </c:pt>
                <c:pt idx="1">
                  <c:v>&gt;100</c:v>
                </c:pt>
                <c:pt idx="2">
                  <c:v>&gt;110</c:v>
                </c:pt>
                <c:pt idx="3">
                  <c:v>&gt;126</c:v>
                </c:pt>
                <c:pt idx="4">
                  <c:v>&gt;130</c:v>
                </c:pt>
                <c:pt idx="5">
                  <c:v>&gt;140</c:v>
                </c:pt>
                <c:pt idx="6">
                  <c:v>140-219</c:v>
                </c:pt>
                <c:pt idx="7">
                  <c:v>&gt;141</c:v>
                </c:pt>
                <c:pt idx="8">
                  <c:v>&gt;150</c:v>
                </c:pt>
                <c:pt idx="9">
                  <c:v>150-170</c:v>
                </c:pt>
                <c:pt idx="10">
                  <c:v>&gt;153</c:v>
                </c:pt>
                <c:pt idx="11">
                  <c:v>&gt;160</c:v>
                </c:pt>
                <c:pt idx="12">
                  <c:v>&gt;169</c:v>
                </c:pt>
                <c:pt idx="13">
                  <c:v>&gt;180</c:v>
                </c:pt>
                <c:pt idx="14">
                  <c:v>&gt;200</c:v>
                </c:pt>
                <c:pt idx="15">
                  <c:v>&gt;220</c:v>
                </c:pt>
              </c:strCache>
            </c:strRef>
          </c:cat>
          <c:val>
            <c:numRef>
              <c:f>Graph!$C$1:$C$16</c:f>
              <c:numCache>
                <c:formatCode>General</c:formatCode>
                <c:ptCount val="16"/>
                <c:pt idx="0">
                  <c:v>51378</c:v>
                </c:pt>
                <c:pt idx="1">
                  <c:v>208</c:v>
                </c:pt>
                <c:pt idx="2">
                  <c:v>1295</c:v>
                </c:pt>
                <c:pt idx="3">
                  <c:v>2991</c:v>
                </c:pt>
                <c:pt idx="4">
                  <c:v>862</c:v>
                </c:pt>
                <c:pt idx="5">
                  <c:v>338</c:v>
                </c:pt>
                <c:pt idx="6">
                  <c:v>1838</c:v>
                </c:pt>
                <c:pt idx="7">
                  <c:v>498</c:v>
                </c:pt>
                <c:pt idx="8">
                  <c:v>201608</c:v>
                </c:pt>
                <c:pt idx="9">
                  <c:v>66</c:v>
                </c:pt>
                <c:pt idx="10">
                  <c:v>5828</c:v>
                </c:pt>
                <c:pt idx="11">
                  <c:v>386</c:v>
                </c:pt>
                <c:pt idx="12">
                  <c:v>279</c:v>
                </c:pt>
                <c:pt idx="13">
                  <c:v>200185</c:v>
                </c:pt>
                <c:pt idx="14">
                  <c:v>8211</c:v>
                </c:pt>
                <c:pt idx="15">
                  <c:v>18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983-438A-8B19-6680FA20F4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9047320"/>
        <c:axId val="669057120"/>
      </c:lineChart>
      <c:catAx>
        <c:axId val="669054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SHG definition</a:t>
                </a:r>
                <a:r>
                  <a:rPr lang="en-GB" baseline="0"/>
                  <a:t> (mg/dL)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9049280"/>
        <c:crosses val="autoZero"/>
        <c:auto val="1"/>
        <c:lblAlgn val="ctr"/>
        <c:lblOffset val="100"/>
        <c:noMultiLvlLbl val="0"/>
      </c:catAx>
      <c:valAx>
        <c:axId val="66904928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stud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9054768"/>
        <c:crosses val="autoZero"/>
        <c:crossBetween val="between"/>
      </c:valAx>
      <c:valAx>
        <c:axId val="669057120"/>
        <c:scaling>
          <c:orientation val="minMax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No. 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9047320"/>
        <c:crosses val="max"/>
        <c:crossBetween val="between"/>
      </c:valAx>
      <c:catAx>
        <c:axId val="6690473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66905712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7236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3382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1991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126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394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591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935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859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3990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97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5705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6A394-1C51-488C-ABA2-0070FD193049}" type="datetimeFigureOut">
              <a:rPr lang="en-GB" smtClean="0"/>
              <a:t>15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26432-C9D1-45A6-95FB-591A7C92FC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59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257175" y="561975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.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57175" y="3264703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B.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638550" y="3264703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.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57175" y="5714364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D.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57175" y="8239754"/>
            <a:ext cx="514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E.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46539" y="11328118"/>
            <a:ext cx="66114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upplementary Figure 1: Blood glucose variables by number of studies and patients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8354348"/>
              </p:ext>
            </p:extLst>
          </p:nvPr>
        </p:nvGraphicFramePr>
        <p:xfrm>
          <a:off x="-123825" y="3524723"/>
          <a:ext cx="3693797" cy="24003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7772347"/>
              </p:ext>
            </p:extLst>
          </p:nvPr>
        </p:nvGraphicFramePr>
        <p:xfrm>
          <a:off x="3294655" y="3500224"/>
          <a:ext cx="3693600" cy="2420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5020011"/>
              </p:ext>
            </p:extLst>
          </p:nvPr>
        </p:nvGraphicFramePr>
        <p:xfrm>
          <a:off x="-266700" y="5925044"/>
          <a:ext cx="7194549" cy="2716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8879282"/>
              </p:ext>
            </p:extLst>
          </p:nvPr>
        </p:nvGraphicFramePr>
        <p:xfrm>
          <a:off x="-123824" y="8641574"/>
          <a:ext cx="7112080" cy="2727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7336483"/>
              </p:ext>
            </p:extLst>
          </p:nvPr>
        </p:nvGraphicFramePr>
        <p:xfrm>
          <a:off x="-123825" y="651513"/>
          <a:ext cx="711208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305815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4</TotalTime>
  <Words>77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MR</dc:creator>
  <cp:lastModifiedBy>PHMR</cp:lastModifiedBy>
  <cp:revision>30</cp:revision>
  <dcterms:created xsi:type="dcterms:W3CDTF">2017-12-07T09:04:54Z</dcterms:created>
  <dcterms:modified xsi:type="dcterms:W3CDTF">2018-03-15T19:02:04Z</dcterms:modified>
</cp:coreProperties>
</file>